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253D4-9EA8-459A-B071-051B17AE27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4D4F60-4FFA-427E-AC50-F2FD818924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34886C-617A-4E7C-BEA7-396A5E57A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AFBFE9-FEBE-4C7D-9052-2B1A074A7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E04091-ED8D-4773-8A7D-E1B57DCEE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5524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CAB89-5004-4E1A-ABAE-CD53D7B38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4C5F4B-B16A-4D96-B6EA-C050F93305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A61FA1-A20D-4A1B-9134-ACA767509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6FE860-45F8-4616-9BEB-E3E5C5E40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69DDA-7103-46FC-BE7B-C35FA9642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5523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ED6D5B-FC96-46F8-A688-599808137D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C9135B-5791-4577-B39D-A141AA845B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F3BA69-7CC2-4F21-8A51-1529F2A9C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5E5C73-8A74-4180-9EB5-1034327C3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FEC6E-7DD3-4B1F-867E-C8C0DE161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1738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6686A-A9AF-49CC-B6DD-EF7356304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4B7B20-1C93-4DAC-9101-A0D427292D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918DB-73E2-4221-8668-3DC841F87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849A6B-E353-4721-9795-10F2BDEF1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392A5-8CDC-4688-B34C-FC005F3E6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586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B16DB-21EC-4A4F-8661-1FC427B96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C0429B-3CD6-49F2-8751-0520E9A65F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8F8159-266F-48D3-B7EE-C97E7414C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EFE36-A836-477C-8C1E-9213A0C52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80F55C-8686-4801-B4CE-93B887C54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0313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774A1A-F2ED-4B0D-A496-457B86A07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1D9308-6D48-48D9-8B12-C5C07578FC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22CAAE-4FA7-498A-8358-19D00D2316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0AF74F-16DA-455B-A998-E4FE0B1CC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EAE995-9EFE-40ED-A300-FC1828E29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0BE0AE-E843-48B3-AB9F-6D04AB982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518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F83864-C4F1-4201-83E6-F58971885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A79721-0FCC-47BD-9FDC-5E90B0C6F6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65D304-8034-4826-9DD4-B7200E401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A7BB08-E8C7-44C2-9C28-24239A8760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C61B67-1390-4A50-BF0A-677EAB97FA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6D219E-8FD8-4C79-95C0-86FB5D9C2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77EF83A-8A18-44EC-9775-B6293B081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422B8D-892F-40FB-9D88-39F654C75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4530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0299E-9C53-4F57-8E9A-D585D8786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C38DA4-3DA5-417E-9763-CC28709AF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A8E6B6-2F67-4257-A766-170F77288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61858E-4FD1-420C-80D5-7E673078E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1943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7F8916-F25C-4A36-B788-D2428A2B1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C421E5-071A-42C8-B055-F97B9CBDB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77B7F9-B072-415D-B374-632057452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1710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78817-165A-456E-9535-F9EFD027FC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575E1-FA43-46B3-8DAB-DE0AA1922C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4C7220-B15B-4745-8654-F25284F49C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F9A4D1-2560-43F5-8EC7-7EA0A34A0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3E0BE2-3C9F-4AB1-84A7-E7D7F4C9A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805D9F-FFB1-4CBC-9584-405673A2F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7113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D9334B-8241-465B-A468-941C696383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E23F5B-1B44-400D-A696-118E356C31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26E811-9D82-46B2-98C7-8819D8FC1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363563-0B06-4A1B-9794-51E8EFA7F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6B46A0-AC3F-43F5-B444-FCAE54713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C7702A-A18E-4EFB-BF35-F16B06DBE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5929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5FDCF0C-A428-406D-98FB-F0FDCC1FF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1CE3ED-AAA5-4B05-BDF9-D9C4FA62BA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9A81D2-8D33-4B29-8632-EED26D204B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5A699-774B-4F5D-AF40-C7F4FCC09151}" type="datetimeFigureOut">
              <a:rPr lang="en-IN" smtClean="0"/>
              <a:t>21-07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5254E1-1244-4B04-92C7-E5C04D2908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D80CD-14B9-4AB0-9CEA-4280F55A35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8B3D0-5D6C-493A-BE4B-ED77639858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3036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37B53E3-00B5-4A8B-A3C5-B9D5ECCA7C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8897054"/>
              </p:ext>
            </p:extLst>
          </p:nvPr>
        </p:nvGraphicFramePr>
        <p:xfrm>
          <a:off x="2368197" y="588454"/>
          <a:ext cx="7455605" cy="577325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871198">
                  <a:extLst>
                    <a:ext uri="{9D8B030D-6E8A-4147-A177-3AD203B41FA5}">
                      <a16:colId xmlns:a16="http://schemas.microsoft.com/office/drawing/2014/main" val="2879065139"/>
                    </a:ext>
                  </a:extLst>
                </a:gridCol>
                <a:gridCol w="1094113">
                  <a:extLst>
                    <a:ext uri="{9D8B030D-6E8A-4147-A177-3AD203B41FA5}">
                      <a16:colId xmlns:a16="http://schemas.microsoft.com/office/drawing/2014/main" val="2280060419"/>
                    </a:ext>
                  </a:extLst>
                </a:gridCol>
                <a:gridCol w="2792654">
                  <a:extLst>
                    <a:ext uri="{9D8B030D-6E8A-4147-A177-3AD203B41FA5}">
                      <a16:colId xmlns:a16="http://schemas.microsoft.com/office/drawing/2014/main" val="830010584"/>
                    </a:ext>
                  </a:extLst>
                </a:gridCol>
                <a:gridCol w="2697640">
                  <a:extLst>
                    <a:ext uri="{9D8B030D-6E8A-4147-A177-3AD203B41FA5}">
                      <a16:colId xmlns:a16="http://schemas.microsoft.com/office/drawing/2014/main" val="2597852448"/>
                    </a:ext>
                  </a:extLst>
                </a:gridCol>
              </a:tblGrid>
              <a:tr h="1436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Region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Country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GenBank Accession Number </a:t>
                      </a:r>
                      <a:r>
                        <a:rPr lang="en-US" sz="12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msp1</a:t>
                      </a:r>
                      <a:r>
                        <a:rPr lang="en-US" sz="1200" b="1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GenBank Accession Number </a:t>
                      </a:r>
                      <a:r>
                        <a:rPr lang="en-IN" sz="1200" i="1" dirty="0">
                          <a:effectLst/>
                          <a:latin typeface="+mn-lt"/>
                        </a:rPr>
                        <a:t>Pvama1</a:t>
                      </a:r>
                      <a:endParaRPr lang="en-IN" sz="1200" i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78747489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outh As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India_OLD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AF435639, EU430452-EU430479,KF612323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EF025187–EF025197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393620198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India_New*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</a:rPr>
                        <a:t>MH657121 - MH657220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+mn-lt"/>
                        </a:rPr>
                        <a:t>MH657021 - MH657120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868757817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hrilank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GU175174-GU175268, AJ292349-AJ292359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EF218679–EF218701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168397267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Bangladesh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AF435616-AF435620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3212467128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954297944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East As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outh Kore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AF435636-AF435638, HQ171934-HQ171941,JQ446312-JQ446322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KM230319–KM230384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608009725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Chin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JX993755-JX993754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KX495505–KX495577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567644686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897000505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West As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Turkey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AB564559-AB564588, KC692069-KC692078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055065786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Iran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JX624732–JX624760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130344782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193820287"/>
                  </a:ext>
                </a:extLst>
              </a:tr>
              <a:tr h="3843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outheast As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Thailand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GQ890872-GQ891041, AF199393-AF199410, AF435595-AF435615, GQ912337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FJ784891–FJ785121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84933960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Myanmar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JX490129-JX490156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094863905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ingapore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GU971656-GU971705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86949580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Cambod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JX461286-JX461333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3111214749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657249445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South Americ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Brazil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AF199405-AF199407, AF435622-AF435631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3429919894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Venezuel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EU346015–EU346087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501309928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689538018"/>
                  </a:ext>
                </a:extLst>
              </a:tr>
              <a:tr h="2542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North America 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Maxico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KP759850-KP759884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752507085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3590008080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Oceania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Vanuatu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AF435632-AF435634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2673620363"/>
                  </a:ext>
                </a:extLst>
              </a:tr>
              <a:tr h="143602">
                <a:tc>
                  <a:txBody>
                    <a:bodyPr/>
                    <a:lstStyle/>
                    <a:p>
                      <a:endParaRPr lang="en-IN" sz="1200"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PNG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+mn-lt"/>
                        </a:rPr>
                        <a:t>-</a:t>
                      </a:r>
                      <a:endParaRPr lang="en-IN" sz="12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+mn-lt"/>
                        </a:rPr>
                        <a:t>KC702402–KC702503</a:t>
                      </a:r>
                      <a:endParaRPr lang="en-IN" sz="12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709" marR="49709" marT="0" marB="0"/>
                </a:tc>
                <a:extLst>
                  <a:ext uri="{0D108BD9-81ED-4DB2-BD59-A6C34878D82A}">
                    <a16:rowId xmlns:a16="http://schemas.microsoft.com/office/drawing/2014/main" val="135264630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24E40392-608D-45AC-BA03-78A86B27A7AD}"/>
              </a:ext>
            </a:extLst>
          </p:cNvPr>
          <p:cNvSpPr/>
          <p:nvPr/>
        </p:nvSpPr>
        <p:spPr>
          <a:xfrm>
            <a:off x="3179377" y="47056"/>
            <a:ext cx="6611007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400"/>
              </a:spcAft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Table. </a:t>
            </a: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msp1</a:t>
            </a:r>
            <a:r>
              <a:rPr lang="en-US" sz="1600" b="1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6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vama1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quences included in this study</a:t>
            </a:r>
            <a:endParaRPr lang="en-IN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B8E14A4-E728-4B01-AA17-DD8FEC45DDCD}"/>
              </a:ext>
            </a:extLst>
          </p:cNvPr>
          <p:cNvSpPr/>
          <p:nvPr/>
        </p:nvSpPr>
        <p:spPr>
          <a:xfrm>
            <a:off x="2041099" y="6361704"/>
            <a:ext cx="3051989" cy="31265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57200">
              <a:lnSpc>
                <a:spcPct val="107000"/>
              </a:lnSpc>
              <a:spcAft>
                <a:spcPts val="800"/>
              </a:spcAft>
            </a:pPr>
            <a:r>
              <a:rPr lang="en-IN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Generated in the present study</a:t>
            </a:r>
          </a:p>
        </p:txBody>
      </p:sp>
    </p:spTree>
    <p:extLst>
      <p:ext uri="{BB962C8B-B14F-4D97-AF65-F5344CB8AC3E}">
        <p14:creationId xmlns:p14="http://schemas.microsoft.com/office/powerpoint/2010/main" val="1806409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7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omic</dc:creator>
  <cp:lastModifiedBy>Prashant Mallick</cp:lastModifiedBy>
  <cp:revision>1</cp:revision>
  <dcterms:created xsi:type="dcterms:W3CDTF">2021-07-07T11:27:26Z</dcterms:created>
  <dcterms:modified xsi:type="dcterms:W3CDTF">2021-07-21T17:34:43Z</dcterms:modified>
</cp:coreProperties>
</file>